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>
        <p:scale>
          <a:sx n="109" d="100"/>
          <a:sy n="109" d="100"/>
        </p:scale>
        <p:origin x="144" y="4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71C44C-0AF8-4337-42C0-6799CE1A9E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74E37A-F359-8F98-9EFC-A9D9BDB94D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2F4220-3157-927E-0A67-CBBB865C0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E8F003-2B0B-3965-BC41-4AEF6F4C86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21B75A-14ED-A063-7805-35CFF15F8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369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ED6CCA-7851-009C-5826-BA15FD25EE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49EEBE-FE06-A187-A042-689AA74FAD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536A44-E066-C335-9E2B-A55583211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224ABE-1275-A5D9-B284-17D99568A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0D9241-1EEF-8EEE-224F-CC6A8BB58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889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71DE4C6-8794-E5F7-0813-1E49F33EEE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C94AAA-6846-9BDF-4381-D2130F45E8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C0BB9E-924E-A86E-AABF-3259D52DE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1436A9-0CC1-2DA6-E787-E7F205BFA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52BFCD-734E-A075-96DE-837C26C12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755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89547-03BC-294C-4F2F-36E8C6B2E7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75589-C096-1AE9-08BD-FDF1C16E96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279052-E480-109F-9386-67001F9B1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4C1581-2EE0-D7A0-5053-85E416FD6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7E5518-A9A8-5D9C-1DC8-B9428839B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945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B2D38F-17A4-4A67-C5DE-2280C58EC9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ADFC6A-01C9-1AF6-884D-724654D300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CC263E-D00E-546C-6FB5-402F9766E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A7CA5-6EE7-A24A-D961-345A909AE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CF4986-F848-5385-AE16-877C438C6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395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BCA372-51BD-2944-EE65-2E4533F73B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BE2303-1B3B-E77A-B6B0-2428A39985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EF7B53-1F25-121B-608A-A067297920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3C5334-BCA6-23EF-3B2E-30B9454C3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2EFF61-2DBF-F6A7-07B3-6254DE382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F9715C-BC42-6BD7-82F3-40D6ED079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875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01AE63-9766-B555-C213-93FC44BE9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0FA76E-241E-5037-8F1E-4ABCC6E32A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4A383A-707C-422A-41F5-575AB1D4A1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2D89C2-6B6D-518B-80C5-E9397CA4E5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242304-9423-1C8D-50C8-50D8EC9476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FDC571-CFCF-E796-49A3-AFD5040D5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C5C7A4B-2D8B-96CF-9F6C-AF9850C6F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A14A54-FE52-3A4F-3EA3-75274999F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345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A6DDEB-6E10-5EEF-6994-B3D8B6427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CA7927B-3B20-BC7F-C774-C2F5135EE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6FD13F-9A05-D9D8-11F9-6AA2F6A1B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744278-7DE1-B09E-4129-4CE196011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979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AD48F1-7215-EBEE-DEF1-DF7647353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18E360-66FE-772F-AC11-D30A3CFAD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4FA830-6E1B-5076-6465-49C6137603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313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7B383-1EB3-7A1D-D00C-173D4EC0B3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ACBF17-4E08-3518-16EF-7078C1EE07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C3148F-C92C-728E-E628-BDDA0BD6C1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D246D7-8D97-E6E7-DF43-4CC2B7F47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7DB4B7-D70F-720C-5AAB-8768FEFFA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E328D9-5197-E211-D542-137A464E6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447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BDCFF5-8F4A-39B1-00C9-4B846A733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C52920-AD8A-7726-371E-8DE0D3D59E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9FA1A5-0C45-4CEB-5469-D07A320EF0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B1D177-9E05-64BC-CA02-0AF5A5D3C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ED737D-1F92-D4F0-C2FB-6EB5BB30C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D12E9E-1DF8-C6D8-B3DB-8F15220D9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154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E40A69-CF38-7DFA-07D7-56259FA468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E96053-9C0F-CF8E-E4C9-B106B381FB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47D23-3E53-BE0C-D48D-C2B97358BC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3A999-2348-AE49-B313-B42F46F52DF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AA9E1-7F9D-ED4C-C9DC-B08D2D5C73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E835EE-9497-87A7-F4E4-2BF88E49E8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F72DE-867D-594C-B84D-BC014A4DB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455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9B4A93-02F9-7F36-BAD2-FD2B47F36F0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cute Exacerbation of COPD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A35EFD-4256-22E0-2C4F-02366A402FC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Stimuli</a:t>
            </a:r>
          </a:p>
        </p:txBody>
      </p:sp>
    </p:spTree>
    <p:extLst>
      <p:ext uri="{BB962C8B-B14F-4D97-AF65-F5344CB8AC3E}">
        <p14:creationId xmlns:p14="http://schemas.microsoft.com/office/powerpoint/2010/main" val="15136164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321243C-4DA2-006D-5664-0DEDB18FB179}"/>
              </a:ext>
            </a:extLst>
          </p:cNvPr>
          <p:cNvSpPr txBox="1"/>
          <p:nvPr/>
        </p:nvSpPr>
        <p:spPr>
          <a:xfrm>
            <a:off x="3048000" y="3246961"/>
            <a:ext cx="609600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oint of care glucose			</a:t>
            </a:r>
            <a:r>
              <a:rPr lang="en-US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146mg/dL</a:t>
            </a:r>
            <a:endParaRPr lang="en-US" sz="22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12331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4184E3E-2C6B-3BFB-0F8D-DD8AD12C12A7}"/>
              </a:ext>
            </a:extLst>
          </p:cNvPr>
          <p:cNvSpPr txBox="1"/>
          <p:nvPr/>
        </p:nvSpPr>
        <p:spPr>
          <a:xfrm>
            <a:off x="2556439" y="2197893"/>
            <a:ext cx="7924800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da-DK" sz="2200" b="1" i="1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rterial</a:t>
            </a:r>
            <a:r>
              <a:rPr lang="da-DK" sz="22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</a:t>
            </a:r>
            <a:r>
              <a:rPr lang="da-DK" sz="2200" b="1" i="1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lood</a:t>
            </a:r>
            <a:r>
              <a:rPr lang="da-DK" sz="22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gas (ABG)	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da-DK" sz="2200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</a:t>
            </a:r>
            <a:endParaRPr lang="en-US" sz="22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da-DK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H 				7.10</a:t>
            </a:r>
            <a:endParaRPr lang="en-US" sz="22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da-DK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CO2 		</a:t>
            </a:r>
            <a:r>
              <a:rPr lang="da-DK" sz="2200" dirty="0">
                <a:solidFill>
                  <a:srgbClr val="000000"/>
                </a:solidFill>
                <a:latin typeface="Calibri" panose="020F0502020204030204" pitchFamily="34" charset="0"/>
                <a:ea typeface="Arial Unicode MS" panose="020B0604020202020204" pitchFamily="34" charset="-128"/>
              </a:rPr>
              <a:t>	</a:t>
            </a:r>
            <a:r>
              <a:rPr lang="da-DK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&gt;110 </a:t>
            </a:r>
            <a:r>
              <a:rPr lang="da-DK" sz="2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mHg</a:t>
            </a:r>
            <a:endParaRPr lang="en-US" sz="22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da-DK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O2 				79.2 </a:t>
            </a:r>
            <a:r>
              <a:rPr lang="da-DK" sz="2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mHg</a:t>
            </a:r>
            <a:endParaRPr lang="en-US" sz="22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pt-BR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HCO</a:t>
            </a:r>
            <a:r>
              <a:rPr lang="pt-BR" sz="22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r>
              <a:rPr lang="pt-BR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				34.5 mmol/L</a:t>
            </a:r>
            <a:endParaRPr lang="en-US" sz="22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pt-BR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O</a:t>
            </a:r>
            <a:r>
              <a:rPr lang="pt-BR" sz="22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2</a:t>
            </a:r>
            <a:r>
              <a:rPr lang="pt-BR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Sat 				87.8 %</a:t>
            </a:r>
            <a:endParaRPr lang="en-US" sz="22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2266759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848AF50-EAB9-B42E-0FFA-99FFB86FF6B7}"/>
              </a:ext>
            </a:extLst>
          </p:cNvPr>
          <p:cNvSpPr txBox="1"/>
          <p:nvPr/>
        </p:nvSpPr>
        <p:spPr>
          <a:xfrm>
            <a:off x="2930770" y="2567225"/>
            <a:ext cx="7537938" cy="17235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mplete blood count (CBC)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White blood count (WBC) 		12.0 x1000/mm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oglobin (Hgb)			12.0 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atocrit (HCT)			43.3%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latelet (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lt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) 			212 x1000/mm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6878573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858DB24-EA6B-2567-AA16-6C30A78218F3}"/>
              </a:ext>
            </a:extLst>
          </p:cNvPr>
          <p:cNvSpPr txBox="1"/>
          <p:nvPr/>
        </p:nvSpPr>
        <p:spPr>
          <a:xfrm>
            <a:off x="3048000" y="1305342"/>
            <a:ext cx="6096000" cy="42165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mplete metabolic panel (CMP)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600" b="1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Sodium 				137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hloride  				100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otassium			4.7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icarbonate (HCO</a:t>
            </a:r>
            <a:r>
              <a:rPr lang="en-US" sz="1800" baseline="-25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)			31.5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 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lood Urea Nitrogen (BUN)		26 mg/dL  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reatine (Cr)		 	1.1 mg/dL 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Glucose 				144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Total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ilirubin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	1.2 mg/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kaline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hosphatase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62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units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spartate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minotransferase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40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units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anine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minotransferase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42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units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bumin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		3.1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units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Total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rotein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	7.2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units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0812086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075625E-33D9-A77A-C5FE-038BC6C845AC}"/>
              </a:ext>
            </a:extLst>
          </p:cNvPr>
          <p:cNvSpPr txBox="1"/>
          <p:nvPr/>
        </p:nvSpPr>
        <p:spPr>
          <a:xfrm>
            <a:off x="4806462" y="32443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Troponin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&lt;0.012 ng/m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1942613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1FB2345-BA29-A5B6-59EC-533C7CD1D7B2}"/>
              </a:ext>
            </a:extLst>
          </p:cNvPr>
          <p:cNvSpPr txBox="1"/>
          <p:nvPr/>
        </p:nvSpPr>
        <p:spPr>
          <a:xfrm>
            <a:off x="5029200" y="32443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Lactate	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1.8 mmol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6145930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, document&#10;&#10;Description automatically generated">
            <a:extLst>
              <a:ext uri="{FF2B5EF4-FFF2-40B4-BE49-F238E27FC236}">
                <a16:creationId xmlns:a16="http://schemas.microsoft.com/office/drawing/2014/main" id="{1AF9710C-CA2C-9247-1782-24CEFF33E6B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350" y="495951"/>
            <a:ext cx="11559300" cy="58660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78807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X-ray of a person's chest&#10;&#10;Description automatically generated with medium confidence">
            <a:extLst>
              <a:ext uri="{FF2B5EF4-FFF2-40B4-BE49-F238E27FC236}">
                <a16:creationId xmlns:a16="http://schemas.microsoft.com/office/drawing/2014/main" id="{5D893D18-51A8-05FD-DFDA-766265E9608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200" y="457200"/>
            <a:ext cx="5943600" cy="594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6132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52</Words>
  <Application>Microsoft Macintosh PowerPoint</Application>
  <PresentationFormat>Widescreen</PresentationFormat>
  <Paragraphs>33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Acute Exacerbation of COPD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ute Exacerbation of COPD</dc:title>
  <dc:creator>Toohey, Shannon</dc:creator>
  <cp:lastModifiedBy>Toohey, Shannon</cp:lastModifiedBy>
  <cp:revision>5</cp:revision>
  <dcterms:created xsi:type="dcterms:W3CDTF">2023-04-29T18:13:15Z</dcterms:created>
  <dcterms:modified xsi:type="dcterms:W3CDTF">2023-04-29T18:17:06Z</dcterms:modified>
</cp:coreProperties>
</file>